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B3C82-FC8D-439C-9008-18E0362EE2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AB43A-7EC3-45EC-ACD5-95EB09769F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473D2-36EA-4086-A11B-2C4FB0CF99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646C4-DC15-41C2-BBAE-B2FF9EE503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835B8-9763-4A64-963C-F066FC3A73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ACB7D-84B0-46FB-8320-E33935CD72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9A8F9-1FB6-4C5F-808D-93ED883357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23106-86ED-464E-81B7-5A7A51CC3D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B6A3E-4DE8-4970-A092-F99A623B67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6A94E-D57D-4B78-8452-5890C1FA62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69936-DDB5-4876-A101-8E9470263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CE4F6-B401-4A84-8DBB-02C5459AE2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92347F-F1B0-45F0-8BDB-FDD770649A5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C:\Users\chuyuye\AppData\Roaming\Tencent\Users\272921624\QQ\WinTemp\RichOle\$UB%NGOG8YQ[1)8($S5V4X4.jpg"/>
          <p:cNvPicPr/>
          <p:nvPr/>
        </p:nvPicPr>
        <p:blipFill>
          <a:blip r:embed="rId1"/>
          <a:stretch/>
        </p:blipFill>
        <p:spPr>
          <a:xfrm>
            <a:off x="838080" y="76320"/>
            <a:ext cx="5600880" cy="31892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C:\Users\chuyuye\AppData\Roaming\Tencent\Users\272921624\QQ\WinTemp\RichOle\@8[7[TFGE{FM4RAHOC_LS9N.jpg"/>
          <p:cNvPicPr/>
          <p:nvPr/>
        </p:nvPicPr>
        <p:blipFill>
          <a:blip r:embed="rId2"/>
          <a:stretch/>
        </p:blipFill>
        <p:spPr>
          <a:xfrm>
            <a:off x="685800" y="3581280"/>
            <a:ext cx="5638680" cy="350532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76320" y="7507440"/>
            <a:ext cx="6705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first 20%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whole chloroplast genome sequences) and 10%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coding sequences of single copy genes) MCMC samples have been discarded as burn i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97360" y="1371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297360" y="48880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04:16:49Z</dcterms:created>
  <dc:creator>Chuyu YE</dc:creator>
  <dc:description/>
  <cp:keywords/>
  <dc:language>en-US</dc:language>
  <cp:lastModifiedBy>user</cp:lastModifiedBy>
  <dcterms:modified xsi:type="dcterms:W3CDTF">2014-11-01T04:17:11Z</dcterms:modified>
  <cp:revision>1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